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9314-C749-4DE4-AAA2-3D67C384343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9AFEF-C838-4A1B-B928-0A153974D90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16692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9314-C749-4DE4-AAA2-3D67C384343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9AFEF-C838-4A1B-B928-0A153974D90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960023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9314-C749-4DE4-AAA2-3D67C384343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9AFEF-C838-4A1B-B928-0A153974D90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7852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9314-C749-4DE4-AAA2-3D67C384343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9AFEF-C838-4A1B-B928-0A153974D90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912977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9314-C749-4DE4-AAA2-3D67C384343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9AFEF-C838-4A1B-B928-0A153974D90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50376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9314-C749-4DE4-AAA2-3D67C384343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9AFEF-C838-4A1B-B928-0A153974D90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51744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9314-C749-4DE4-AAA2-3D67C384343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9AFEF-C838-4A1B-B928-0A153974D90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46487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9314-C749-4DE4-AAA2-3D67C384343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9AFEF-C838-4A1B-B928-0A153974D90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13535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9314-C749-4DE4-AAA2-3D67C384343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9AFEF-C838-4A1B-B928-0A153974D90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392445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9314-C749-4DE4-AAA2-3D67C384343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9AFEF-C838-4A1B-B928-0A153974D90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92913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9314-C749-4DE4-AAA2-3D67C384343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9AFEF-C838-4A1B-B928-0A153974D90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24376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1F9314-C749-4DE4-AAA2-3D67C3843433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F9AFEF-C838-4A1B-B928-0A153974D90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24898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B4184F6B-9E24-4950-9182-0CFFA023710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0480" y="1392865"/>
            <a:ext cx="8944602" cy="4343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9CE0364-EB09-4981-99EA-008CEE7B0CDE}"/>
              </a:ext>
            </a:extLst>
          </p:cNvPr>
          <p:cNvSpPr txBox="1"/>
          <p:nvPr/>
        </p:nvSpPr>
        <p:spPr>
          <a:xfrm>
            <a:off x="6369267" y="2077655"/>
            <a:ext cx="25779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Epigallocatechin gallate pure standard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1AE5B11-ED7F-421A-9AD6-630CAA923DA8}"/>
              </a:ext>
            </a:extLst>
          </p:cNvPr>
          <p:cNvSpPr txBox="1"/>
          <p:nvPr/>
        </p:nvSpPr>
        <p:spPr>
          <a:xfrm>
            <a:off x="6801716" y="4358833"/>
            <a:ext cx="19207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 err="1">
                <a:latin typeface="Arial" panose="020B0604020202020204" pitchFamily="34" charset="0"/>
                <a:cs typeface="Arial" panose="020B0604020202020204" pitchFamily="34" charset="0"/>
              </a:rPr>
              <a:t>Marula</a:t>
            </a:r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 stem ethanol extrac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A8480B3-D3A0-44C0-9A6A-50B6818EFE0A}"/>
              </a:ext>
            </a:extLst>
          </p:cNvPr>
          <p:cNvSpPr txBox="1"/>
          <p:nvPr/>
        </p:nvSpPr>
        <p:spPr>
          <a:xfrm>
            <a:off x="1605987" y="5832677"/>
            <a:ext cx="850073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Additional file 8</a:t>
            </a:r>
          </a:p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Negative mode BPI chromatogram of epigallocatechin gallate pure standard overlaid with that of </a:t>
            </a:r>
            <a:r>
              <a:rPr lang="en-ZA" sz="1100" dirty="0" err="1">
                <a:latin typeface="Arial" panose="020B0604020202020204" pitchFamily="34" charset="0"/>
                <a:cs typeface="Arial" panose="020B0604020202020204" pitchFamily="34" charset="0"/>
              </a:rPr>
              <a:t>Marula</a:t>
            </a:r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  stem ethanol extract </a:t>
            </a:r>
          </a:p>
          <a:p>
            <a:endParaRPr lang="en-ZA" dirty="0"/>
          </a:p>
        </p:txBody>
      </p:sp>
    </p:spTree>
    <p:extLst>
      <p:ext uri="{BB962C8B-B14F-4D97-AF65-F5344CB8AC3E}">
        <p14:creationId xmlns:p14="http://schemas.microsoft.com/office/powerpoint/2010/main" val="353031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8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no</dc:creator>
  <cp:lastModifiedBy>Tino</cp:lastModifiedBy>
  <cp:revision>4</cp:revision>
  <dcterms:created xsi:type="dcterms:W3CDTF">2017-04-22T14:03:26Z</dcterms:created>
  <dcterms:modified xsi:type="dcterms:W3CDTF">2017-09-21T09:24:59Z</dcterms:modified>
</cp:coreProperties>
</file>